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14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C9AA0-F29A-45DF-BE6B-748FCA59AE3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035-3005-4237-9516-CD93D30633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4165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C9AA0-F29A-45DF-BE6B-748FCA59AE3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035-3005-4237-9516-CD93D30633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661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C9AA0-F29A-45DF-BE6B-748FCA59AE3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035-3005-4237-9516-CD93D30633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88782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C9AA0-F29A-45DF-BE6B-748FCA59AE3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035-3005-4237-9516-CD93D30633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756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C9AA0-F29A-45DF-BE6B-748FCA59AE3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035-3005-4237-9516-CD93D30633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79672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C9AA0-F29A-45DF-BE6B-748FCA59AE3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035-3005-4237-9516-CD93D30633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559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C9AA0-F29A-45DF-BE6B-748FCA59AE3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035-3005-4237-9516-CD93D30633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4206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C9AA0-F29A-45DF-BE6B-748FCA59AE3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035-3005-4237-9516-CD93D30633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849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C9AA0-F29A-45DF-BE6B-748FCA59AE3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035-3005-4237-9516-CD93D30633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1961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C9AA0-F29A-45DF-BE6B-748FCA59AE3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035-3005-4237-9516-CD93D30633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266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C9AA0-F29A-45DF-BE6B-748FCA59AE3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4E2035-3005-4237-9516-CD93D30633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820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AC9AA0-F29A-45DF-BE6B-748FCA59AE37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4E2035-3005-4237-9516-CD93D30633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7784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0053856"/>
              </p:ext>
            </p:extLst>
          </p:nvPr>
        </p:nvGraphicFramePr>
        <p:xfrm>
          <a:off x="533400" y="838200"/>
          <a:ext cx="7924798" cy="566928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95399"/>
                <a:gridCol w="1290929"/>
                <a:gridCol w="918871"/>
                <a:gridCol w="1828800"/>
                <a:gridCol w="1676400"/>
                <a:gridCol w="914399"/>
              </a:tblGrid>
              <a:tr h="504596">
                <a:tc>
                  <a:txBody>
                    <a:bodyPr/>
                    <a:lstStyle/>
                    <a:p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A sample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ge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N</a:t>
                      </a:r>
                      <a:r>
                        <a:rPr lang="en-US" sz="12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alue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A sample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ge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N value</a:t>
                      </a:r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504596"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 1.1 Control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iferati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6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 </a:t>
                      </a:r>
                      <a:r>
                        <a:rPr lang="en-US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.2 </a:t>
                      </a:r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iferati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9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504596"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 1.2</a:t>
                      </a:r>
                    </a:p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25 D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iferati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6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r>
                        <a:rPr lang="en-US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3.1</a:t>
                      </a:r>
                      <a:endPara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25 D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iferati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504596"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 2.1</a:t>
                      </a:r>
                    </a:p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iferati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8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r>
                        <a:rPr lang="en-US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3.2</a:t>
                      </a:r>
                      <a:endPara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iferati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504596"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 2.2</a:t>
                      </a:r>
                    </a:p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25D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iferati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8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.1 </a:t>
                      </a:r>
                      <a:endPara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25D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iferati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504596"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 3.1</a:t>
                      </a:r>
                    </a:p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iferati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7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.2 </a:t>
                      </a:r>
                      <a:endPara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iferati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6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504596"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 3.2</a:t>
                      </a:r>
                    </a:p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25D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iferati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8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.1</a:t>
                      </a:r>
                      <a:endPara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25D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liferati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712370"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 1.1</a:t>
                      </a:r>
                    </a:p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Proliferati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6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.2 </a:t>
                      </a:r>
                      <a:endPara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Proliferati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5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712370"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 1.2</a:t>
                      </a:r>
                    </a:p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25D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Proliferati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7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3.1</a:t>
                      </a:r>
                      <a:endPara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25D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Proliferati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7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  <a:tr h="712370"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 2.1</a:t>
                      </a:r>
                    </a:p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Proliferati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5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3.2</a:t>
                      </a:r>
                      <a:endPara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Proliferation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8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609600" y="396240"/>
            <a:ext cx="838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smtClean="0">
                <a:latin typeface="Arial" panose="020B0604020202020204" pitchFamily="34" charset="0"/>
                <a:cs typeface="Arial" panose="020B0604020202020204" pitchFamily="34" charset="0"/>
              </a:rPr>
              <a:t>ST2. 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NA integrity number  (RIN) for total RNA samples obtained  from different experimental group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59408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119</Words>
  <Application>Microsoft Office PowerPoint</Application>
  <PresentationFormat>On-screen Show (4:3)</PresentationFormat>
  <Paragraphs>7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Veteran Affair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imella, Rama (KCVA)</dc:creator>
  <cp:lastModifiedBy>Garimella, Rama (KCVA)</cp:lastModifiedBy>
  <cp:revision>9</cp:revision>
  <dcterms:created xsi:type="dcterms:W3CDTF">2016-03-16T18:54:50Z</dcterms:created>
  <dcterms:modified xsi:type="dcterms:W3CDTF">2017-03-14T17:39:05Z</dcterms:modified>
</cp:coreProperties>
</file>